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121" d="100"/>
          <a:sy n="121" d="100"/>
        </p:scale>
        <p:origin x="19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1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2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3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4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5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 sz="1000" dirty="0"/>
          </a:p>
        </c:rich>
      </c:tx>
      <c:layout>
        <c:manualLayout>
          <c:xMode val="edge"/>
          <c:yMode val="edge"/>
          <c:x val="0.15509733158355207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21833664579796075"/>
          <c:y val="0.25411675134111877"/>
          <c:w val="0.72745369968155282"/>
          <c:h val="0.454182977902179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eed germin , diff hrs'!$B$7</c:f>
              <c:strCache>
                <c:ptCount val="1"/>
                <c:pt idx="0">
                  <c:v>seed germination rate</c:v>
                </c:pt>
              </c:strCache>
            </c:strRef>
          </c:tx>
          <c:spPr>
            <a:solidFill>
              <a:srgbClr val="FFC000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C0A-41D9-A091-321E90A31887}"/>
              </c:ext>
            </c:extLst>
          </c:dPt>
          <c:dPt>
            <c:idx val="1"/>
            <c:invertIfNegative val="0"/>
            <c:bubble3D val="0"/>
            <c:spPr>
              <a:solidFill>
                <a:srgbClr val="009999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C0A-41D9-A091-321E90A31887}"/>
              </c:ext>
            </c:extLst>
          </c:dPt>
          <c:dPt>
            <c:idx val="2"/>
            <c:invertIfNegative val="0"/>
            <c:bubble3D val="0"/>
            <c:spPr>
              <a:solidFill>
                <a:srgbClr val="009999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0C0A-41D9-A091-321E90A31887}"/>
              </c:ext>
            </c:extLst>
          </c:dPt>
          <c:dPt>
            <c:idx val="3"/>
            <c:invertIfNegative val="0"/>
            <c:bubble3D val="0"/>
            <c:spPr>
              <a:solidFill>
                <a:srgbClr val="009999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0C0A-41D9-A091-321E90A31887}"/>
              </c:ext>
            </c:extLst>
          </c:dPt>
          <c:dLbls>
            <c:dLbl>
              <c:idx val="0"/>
              <c:layout>
                <c:manualLayout>
                  <c:x val="0.2051243696366368"/>
                  <c:y val="-5.8904277281545361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P</a:t>
                    </a:r>
                    <a:r>
                      <a:rPr lang="en-US" dirty="0" smtClean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&gt;0.05</a:t>
                    </a:r>
                    <a:endParaRPr lang="en-US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0C0A-41D9-A091-321E90A31887}"/>
                </c:ext>
              </c:extLst>
            </c:dLbl>
            <c:dLbl>
              <c:idx val="1"/>
              <c:layout>
                <c:manualLayout>
                  <c:x val="0.20555543483259447"/>
                  <c:y val="-8.5547705746267882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P</a:t>
                    </a:r>
                    <a:r>
                      <a:rPr lang="en-US" dirty="0" smtClean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&gt;0.05</a:t>
                    </a:r>
                    <a:endParaRPr lang="en-US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3-0C0A-41D9-A091-321E90A31887}"/>
                </c:ext>
              </c:extLst>
            </c:dLbl>
            <c:dLbl>
              <c:idx val="2"/>
              <c:layout>
                <c:manualLayout>
                  <c:x val="0.20000010107038593"/>
                  <c:y val="-9.2073075845756441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P</a:t>
                    </a:r>
                    <a:r>
                      <a:rPr lang="en-US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≤0.05</a:t>
                    </a:r>
                    <a:endParaRPr lang="en-US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0C0A-41D9-A091-321E90A31887}"/>
                </c:ext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0C0A-41D9-A091-321E90A31887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-5400000" spcFirstLastPara="1" vertOverflow="ellipsis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seed germin , diff hrs'!$C$8:$F$8</c:f>
                <c:numCache>
                  <c:formatCode>General</c:formatCode>
                  <c:ptCount val="4"/>
                  <c:pt idx="0">
                    <c:v>4.3840620433565967</c:v>
                  </c:pt>
                  <c:pt idx="1">
                    <c:v>5.4447222151364176</c:v>
                  </c:pt>
                  <c:pt idx="2">
                    <c:v>16.334166645409258</c:v>
                  </c:pt>
                  <c:pt idx="3">
                    <c:v>4.4547727214752575</c:v>
                  </c:pt>
                </c:numCache>
              </c:numRef>
            </c:plus>
            <c:minus>
              <c:numRef>
                <c:f>'seed germin , diff hrs'!$C$8:$F$8</c:f>
                <c:numCache>
                  <c:formatCode>General</c:formatCode>
                  <c:ptCount val="4"/>
                  <c:pt idx="0">
                    <c:v>4.3840620433565967</c:v>
                  </c:pt>
                  <c:pt idx="1">
                    <c:v>5.4447222151364176</c:v>
                  </c:pt>
                  <c:pt idx="2">
                    <c:v>16.334166645409258</c:v>
                  </c:pt>
                  <c:pt idx="3">
                    <c:v>4.45477272147525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eed germin , diff hrs'!$C$6:$F$6</c:f>
              <c:strCache>
                <c:ptCount val="4"/>
                <c:pt idx="0">
                  <c:v>0h</c:v>
                </c:pt>
                <c:pt idx="1">
                  <c:v>1h</c:v>
                </c:pt>
                <c:pt idx="2">
                  <c:v>3h</c:v>
                </c:pt>
                <c:pt idx="3">
                  <c:v>6h</c:v>
                </c:pt>
              </c:strCache>
            </c:strRef>
          </c:cat>
          <c:val>
            <c:numRef>
              <c:f>'seed germin , diff hrs'!$C$7:$F$7</c:f>
              <c:numCache>
                <c:formatCode>General</c:formatCode>
                <c:ptCount val="4"/>
                <c:pt idx="0">
                  <c:v>64.599999999999994</c:v>
                </c:pt>
                <c:pt idx="1">
                  <c:v>68.849999999999994</c:v>
                </c:pt>
                <c:pt idx="2">
                  <c:v>73.05</c:v>
                </c:pt>
                <c:pt idx="3">
                  <c:v>87.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6B7-804E-8298-BF889DDA1A7C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338225176"/>
        <c:axId val="338224392"/>
      </c:barChart>
      <c:catAx>
        <c:axId val="3382251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000" b="1"/>
                  <a:t>different time of exposure</a:t>
                </a:r>
              </a:p>
            </c:rich>
          </c:tx>
          <c:layout>
            <c:manualLayout>
              <c:xMode val="edge"/>
              <c:yMode val="edge"/>
              <c:x val="0.33206010758201382"/>
              <c:y val="0.897615618839108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38224392"/>
        <c:crosses val="autoZero"/>
        <c:auto val="1"/>
        <c:lblAlgn val="ctr"/>
        <c:lblOffset val="100"/>
        <c:noMultiLvlLbl val="0"/>
      </c:catAx>
      <c:valAx>
        <c:axId val="3382243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000" b="1"/>
                  <a:t>% of seed germination </a:t>
                </a:r>
              </a:p>
            </c:rich>
          </c:tx>
          <c:layout>
            <c:manualLayout>
              <c:xMode val="edge"/>
              <c:yMode val="edge"/>
              <c:x val="4.4070069099734994E-2"/>
              <c:y val="9.306756411227699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  <a:headEnd type="none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382251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426159230096238"/>
          <c:y val="0.20013620356125206"/>
          <c:w val="0.84518285214348221"/>
          <c:h val="0.623597945609590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Chart in Microsoft PowerPoint]shoot ,root, lenght'!$I$26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rgbClr val="FFC000"/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[Chart in Microsoft PowerPoint]shoot ,root, lenght'!$J$28:$O$28</c:f>
                <c:numCache>
                  <c:formatCode>General</c:formatCode>
                  <c:ptCount val="6"/>
                  <c:pt idx="0">
                    <c:v>3.95</c:v>
                  </c:pt>
                  <c:pt idx="1">
                    <c:v>3.95</c:v>
                  </c:pt>
                  <c:pt idx="2">
                    <c:v>3.95</c:v>
                  </c:pt>
                  <c:pt idx="3">
                    <c:v>0.05</c:v>
                  </c:pt>
                  <c:pt idx="4">
                    <c:v>0.05</c:v>
                  </c:pt>
                  <c:pt idx="5">
                    <c:v>0.05</c:v>
                  </c:pt>
                </c:numCache>
              </c:numRef>
            </c:plus>
            <c:minus>
              <c:numRef>
                <c:f>'[Chart in Microsoft PowerPoint]shoot ,root, lenght'!$J$28:$O$28</c:f>
                <c:numCache>
                  <c:formatCode>General</c:formatCode>
                  <c:ptCount val="6"/>
                  <c:pt idx="0">
                    <c:v>3.95</c:v>
                  </c:pt>
                  <c:pt idx="1">
                    <c:v>3.95</c:v>
                  </c:pt>
                  <c:pt idx="2">
                    <c:v>3.95</c:v>
                  </c:pt>
                  <c:pt idx="3">
                    <c:v>0.05</c:v>
                  </c:pt>
                  <c:pt idx="4">
                    <c:v>0.05</c:v>
                  </c:pt>
                  <c:pt idx="5">
                    <c:v>0.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shoot ,root, lenght'!$J$25:$O$25</c:f>
              <c:strCache>
                <c:ptCount val="6"/>
                <c:pt idx="0">
                  <c:v>root, 1h</c:v>
                </c:pt>
                <c:pt idx="1">
                  <c:v>root, 3h</c:v>
                </c:pt>
                <c:pt idx="2">
                  <c:v>root, 6h</c:v>
                </c:pt>
                <c:pt idx="3">
                  <c:v>shoot, 1h</c:v>
                </c:pt>
                <c:pt idx="4">
                  <c:v>shoot, 3h</c:v>
                </c:pt>
                <c:pt idx="5">
                  <c:v>shoot, 6h</c:v>
                </c:pt>
              </c:strCache>
            </c:strRef>
          </c:cat>
          <c:val>
            <c:numRef>
              <c:f>'[Chart in Microsoft PowerPoint]shoot ,root, lenght'!$J$26:$O$26</c:f>
              <c:numCache>
                <c:formatCode>General</c:formatCode>
                <c:ptCount val="6"/>
                <c:pt idx="0">
                  <c:v>51.53</c:v>
                </c:pt>
                <c:pt idx="1">
                  <c:v>51.53</c:v>
                </c:pt>
                <c:pt idx="2">
                  <c:v>51.53</c:v>
                </c:pt>
                <c:pt idx="3">
                  <c:v>19.8</c:v>
                </c:pt>
                <c:pt idx="4">
                  <c:v>19.8</c:v>
                </c:pt>
                <c:pt idx="5">
                  <c:v>19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4D3-40C5-BF62-3B7282068202}"/>
            </c:ext>
          </c:extLst>
        </c:ser>
        <c:ser>
          <c:idx val="1"/>
          <c:order val="1"/>
          <c:tx>
            <c:strRef>
              <c:f>'[Chart in Microsoft PowerPoint]shoot ,root, lenght'!$I$27</c:f>
              <c:strCache>
                <c:ptCount val="1"/>
                <c:pt idx="0">
                  <c:v>treatment</c:v>
                </c:pt>
              </c:strCache>
            </c:strRef>
          </c:tx>
          <c:spPr>
            <a:solidFill>
              <a:srgbClr val="009999"/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layout>
                <c:manualLayout>
                  <c:x val="-2.7979527209545364E-2"/>
                  <c:y val="3.2917191268601246E-3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P≥0.05</a:t>
                    </a:r>
                    <a:endParaRPr lang="en-US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54D3-40C5-BF62-3B7282068202}"/>
                </c:ext>
              </c:extLst>
            </c:dLbl>
            <c:dLbl>
              <c:idx val="1"/>
              <c:layout>
                <c:manualLayout>
                  <c:x val="-3.8105304992119532E-2"/>
                  <c:y val="4.331249296427965E-2"/>
                </c:manualLayout>
              </c:layout>
              <c:tx>
                <c:rich>
                  <a:bodyPr rot="-5400000" spcFirstLastPara="1" vertOverflow="ellipsis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1000" b="1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sz="1000" b="1" dirty="0" smtClean="0"/>
                      <a:t>P≥0.05</a:t>
                    </a:r>
                    <a:endParaRPr lang="en-US" sz="1000" b="1" dirty="0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-5400000" spcFirstLastPara="1" vertOverflow="ellipsis" wrap="square" lIns="38100" tIns="19050" rIns="38100" bIns="19050" anchor="ctr" anchorCtr="1">
                  <a:noAutofit/>
                </a:bodyPr>
                <a:lstStyle/>
                <a:p>
                  <a:pPr>
                    <a:defRPr sz="1000" b="1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2495844269466316"/>
                      <c:h val="5.0694444444444445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2-54D3-40C5-BF62-3B7282068202}"/>
                </c:ext>
              </c:extLst>
            </c:dLbl>
            <c:dLbl>
              <c:idx val="2"/>
              <c:layout>
                <c:manualLayout>
                  <c:x val="-3.6111023784979449E-2"/>
                  <c:y val="3.8797257087016195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P≥0.05</a:t>
                    </a:r>
                    <a:endParaRPr lang="en-US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3-54D3-40C5-BF62-3B7282068202}"/>
                </c:ext>
              </c:extLst>
            </c:dLbl>
            <c:dLbl>
              <c:idx val="3"/>
              <c:layout>
                <c:manualLayout>
                  <c:x val="-1.9444505703074266E-2"/>
                  <c:y val="-5.738752627666887E-3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P≥0.05</a:t>
                    </a:r>
                    <a:endParaRPr lang="en-US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54D3-40C5-BF62-3B7282068202}"/>
                </c:ext>
              </c:extLst>
            </c:dLbl>
            <c:dLbl>
              <c:idx val="4"/>
              <c:layout>
                <c:manualLayout>
                  <c:x val="-3.0353755292159088E-2"/>
                  <c:y val="3.5048066444344467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P≥0.05</a:t>
                    </a:r>
                    <a:endParaRPr lang="en-US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54D3-40C5-BF62-3B7282068202}"/>
                </c:ext>
              </c:extLst>
            </c:dLbl>
            <c:dLbl>
              <c:idx val="5"/>
              <c:layout>
                <c:manualLayout>
                  <c:x val="-1.9040980772037145E-2"/>
                  <c:y val="-4.1894969968951021E-3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P</a:t>
                    </a:r>
                    <a:r>
                      <a:rPr lang="en-US" dirty="0" smtClean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≤0.01</a:t>
                    </a:r>
                    <a:endParaRPr lang="en-US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6-54D3-40C5-BF62-3B728206820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-5400000" spcFirstLastPara="1" vertOverflow="ellipsis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[Chart in Microsoft PowerPoint]shoot ,root, lenght'!$J$29:$O$29</c:f>
                <c:numCache>
                  <c:formatCode>General</c:formatCode>
                  <c:ptCount val="6"/>
                  <c:pt idx="0">
                    <c:v>5.15</c:v>
                  </c:pt>
                  <c:pt idx="1">
                    <c:v>4.0599999999999996</c:v>
                  </c:pt>
                  <c:pt idx="2">
                    <c:v>7.9</c:v>
                  </c:pt>
                  <c:pt idx="3">
                    <c:v>0.47</c:v>
                  </c:pt>
                  <c:pt idx="4">
                    <c:v>1.7</c:v>
                  </c:pt>
                  <c:pt idx="5">
                    <c:v>0.49</c:v>
                  </c:pt>
                </c:numCache>
              </c:numRef>
            </c:plus>
            <c:minus>
              <c:numRef>
                <c:f>'[Chart in Microsoft PowerPoint]shoot ,root, lenght'!$J$29:$O$29</c:f>
                <c:numCache>
                  <c:formatCode>General</c:formatCode>
                  <c:ptCount val="6"/>
                  <c:pt idx="0">
                    <c:v>5.15</c:v>
                  </c:pt>
                  <c:pt idx="1">
                    <c:v>4.0599999999999996</c:v>
                  </c:pt>
                  <c:pt idx="2">
                    <c:v>7.9</c:v>
                  </c:pt>
                  <c:pt idx="3">
                    <c:v>0.47</c:v>
                  </c:pt>
                  <c:pt idx="4">
                    <c:v>1.7</c:v>
                  </c:pt>
                  <c:pt idx="5">
                    <c:v>0.4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shoot ,root, lenght'!$J$25:$O$25</c:f>
              <c:strCache>
                <c:ptCount val="6"/>
                <c:pt idx="0">
                  <c:v>root, 1h</c:v>
                </c:pt>
                <c:pt idx="1">
                  <c:v>root, 3h</c:v>
                </c:pt>
                <c:pt idx="2">
                  <c:v>root, 6h</c:v>
                </c:pt>
                <c:pt idx="3">
                  <c:v>shoot, 1h</c:v>
                </c:pt>
                <c:pt idx="4">
                  <c:v>shoot, 3h</c:v>
                </c:pt>
                <c:pt idx="5">
                  <c:v>shoot, 6h</c:v>
                </c:pt>
              </c:strCache>
            </c:strRef>
          </c:cat>
          <c:val>
            <c:numRef>
              <c:f>'[Chart in Microsoft PowerPoint]shoot ,root, lenght'!$J$27:$O$27</c:f>
              <c:numCache>
                <c:formatCode>General</c:formatCode>
                <c:ptCount val="6"/>
                <c:pt idx="0">
                  <c:v>64.099999999999994</c:v>
                </c:pt>
                <c:pt idx="1">
                  <c:v>96.2</c:v>
                </c:pt>
                <c:pt idx="2">
                  <c:v>74.599999999999994</c:v>
                </c:pt>
                <c:pt idx="3">
                  <c:v>22.94</c:v>
                </c:pt>
                <c:pt idx="4">
                  <c:v>36.799999999999997</c:v>
                </c:pt>
                <c:pt idx="5">
                  <c:v>26.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54D3-40C5-BF62-3B7282068202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338224000"/>
        <c:axId val="338218512"/>
      </c:barChart>
      <c:catAx>
        <c:axId val="3382240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38218512"/>
        <c:crosses val="autoZero"/>
        <c:auto val="1"/>
        <c:lblAlgn val="ctr"/>
        <c:lblOffset val="100"/>
        <c:noMultiLvlLbl val="0"/>
      </c:catAx>
      <c:valAx>
        <c:axId val="3382185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b="1"/>
                  <a:t>lenght(m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382240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6101093613298341"/>
          <c:y val="0.92187445319335082"/>
          <c:w val="0.29816621379595432"/>
          <c:h val="7.812583580365291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845393263523132"/>
          <c:y val="0.16684144818976276"/>
          <c:w val="0.81144583094742695"/>
          <c:h val="0.6070490626873887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Chart in Microsoft PowerPoint]Biomass barley'!$N$6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rgbClr val="FFC000"/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layout>
                <c:manualLayout>
                  <c:x val="1.6784219277321037E-2"/>
                  <c:y val="-6.7209327021782575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P≥0.05</a:t>
                    </a:r>
                    <a:endParaRPr lang="en-US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0-40A0-4423-ACD8-B9458121A1D5}"/>
                </c:ext>
              </c:extLst>
            </c:dLbl>
            <c:dLbl>
              <c:idx val="1"/>
              <c:layout>
                <c:manualLayout>
                  <c:x val="7.5486772156802169E-3"/>
                  <c:y val="-0.15016295733575738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P</a:t>
                    </a:r>
                    <a:r>
                      <a:rPr lang="en-US" dirty="0" smtClean="0"/>
                      <a:t>≤0.05</a:t>
                    </a:r>
                    <a:endParaRPr lang="en-US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40A0-4423-ACD8-B9458121A1D5}"/>
                </c:ext>
              </c:extLst>
            </c:dLbl>
            <c:dLbl>
              <c:idx val="2"/>
              <c:layout>
                <c:manualLayout>
                  <c:x val="1.6661186168735083E-3"/>
                  <c:y val="-0.12428304837935782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P</a:t>
                    </a:r>
                    <a:r>
                      <a:rPr lang="en-US" dirty="0" smtClean="0"/>
                      <a:t>≤0.05</a:t>
                    </a:r>
                    <a:endParaRPr lang="en-US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2-40A0-4423-ACD8-B9458121A1D5}"/>
                </c:ext>
              </c:extLst>
            </c:dLbl>
            <c:dLbl>
              <c:idx val="3"/>
              <c:layout>
                <c:manualLayout>
                  <c:x val="-1.2797907583686258E-2"/>
                  <c:y val="-0.14824746089003027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P</a:t>
                    </a:r>
                    <a:r>
                      <a:rPr lang="en-US" dirty="0" smtClean="0"/>
                      <a:t>≤0.05</a:t>
                    </a:r>
                    <a:endParaRPr lang="en-US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3-40A0-4423-ACD8-B9458121A1D5}"/>
                </c:ext>
              </c:extLst>
            </c:dLbl>
            <c:dLbl>
              <c:idx val="4"/>
              <c:layout>
                <c:manualLayout>
                  <c:x val="1.1111000871210079E-2"/>
                  <c:y val="-0.13940455209635796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P</a:t>
                    </a:r>
                    <a:r>
                      <a:rPr lang="en-US" dirty="0" smtClean="0"/>
                      <a:t>≤0.05</a:t>
                    </a:r>
                    <a:endParaRPr lang="en-US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40A0-4423-ACD8-B9458121A1D5}"/>
                </c:ext>
              </c:extLst>
            </c:dLbl>
            <c:dLbl>
              <c:idx val="5"/>
              <c:layout>
                <c:manualLayout>
                  <c:x val="1.0758132834259946E-2"/>
                  <c:y val="-6.7688405260769857E-2"/>
                </c:manualLayout>
              </c:layout>
              <c:tx>
                <c:rich>
                  <a:bodyPr/>
                  <a:lstStyle/>
                  <a:p>
                    <a:r>
                      <a:rPr lang="en-US" dirty="0"/>
                      <a:t>P</a:t>
                    </a:r>
                    <a:r>
                      <a:rPr lang="en-US" dirty="0" smtClean="0"/>
                      <a:t>≤0.05</a:t>
                    </a:r>
                    <a:endParaRPr lang="en-US" dirty="0"/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40A0-4423-ACD8-B9458121A1D5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-5400000" spcFirstLastPara="1" vertOverflow="ellipsis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[Chart in Microsoft PowerPoint]Biomass barley'!$O$8:$T$8</c:f>
                <c:numCache>
                  <c:formatCode>General</c:formatCode>
                  <c:ptCount val="6"/>
                  <c:pt idx="0">
                    <c:v>12.790896647109466</c:v>
                  </c:pt>
                  <c:pt idx="1">
                    <c:v>12.790896647109466</c:v>
                  </c:pt>
                  <c:pt idx="2">
                    <c:v>12.790896647109466</c:v>
                  </c:pt>
                  <c:pt idx="3">
                    <c:v>8.847960897124084</c:v>
                  </c:pt>
                  <c:pt idx="4">
                    <c:v>8.847960897124084</c:v>
                  </c:pt>
                  <c:pt idx="5">
                    <c:v>8.847960897124084</c:v>
                  </c:pt>
                </c:numCache>
              </c:numRef>
            </c:plus>
            <c:minus>
              <c:numRef>
                <c:f>'[Chart in Microsoft PowerPoint]Biomass barley'!$O$8:$T$8</c:f>
                <c:numCache>
                  <c:formatCode>General</c:formatCode>
                  <c:ptCount val="6"/>
                  <c:pt idx="0">
                    <c:v>12.790896647109466</c:v>
                  </c:pt>
                  <c:pt idx="1">
                    <c:v>12.790896647109466</c:v>
                  </c:pt>
                  <c:pt idx="2">
                    <c:v>12.790896647109466</c:v>
                  </c:pt>
                  <c:pt idx="3">
                    <c:v>8.847960897124084</c:v>
                  </c:pt>
                  <c:pt idx="4">
                    <c:v>8.847960897124084</c:v>
                  </c:pt>
                  <c:pt idx="5">
                    <c:v>8.84796089712408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Biomass barley'!$O$5:$T$5</c:f>
              <c:strCache>
                <c:ptCount val="6"/>
                <c:pt idx="0">
                  <c:v>root, 1h</c:v>
                </c:pt>
                <c:pt idx="1">
                  <c:v>root, 3h</c:v>
                </c:pt>
                <c:pt idx="2">
                  <c:v>root, 6h</c:v>
                </c:pt>
                <c:pt idx="3">
                  <c:v>shoot, 1h</c:v>
                </c:pt>
                <c:pt idx="4">
                  <c:v>shoot, 3h</c:v>
                </c:pt>
                <c:pt idx="5">
                  <c:v>shoot, 6h</c:v>
                </c:pt>
              </c:strCache>
            </c:strRef>
          </c:cat>
          <c:val>
            <c:numRef>
              <c:f>'[Chart in Microsoft PowerPoint]Biomass barley'!$O$6:$T$6</c:f>
              <c:numCache>
                <c:formatCode>General</c:formatCode>
                <c:ptCount val="6"/>
                <c:pt idx="0">
                  <c:v>66.844444444444449</c:v>
                </c:pt>
                <c:pt idx="1">
                  <c:v>66.844444444444449</c:v>
                </c:pt>
                <c:pt idx="2">
                  <c:v>66.844444444444449</c:v>
                </c:pt>
                <c:pt idx="3">
                  <c:v>70.336111111111109</c:v>
                </c:pt>
                <c:pt idx="4">
                  <c:v>70.336111111111109</c:v>
                </c:pt>
                <c:pt idx="5">
                  <c:v>70.3361111111111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40A0-4423-ACD8-B9458121A1D5}"/>
            </c:ext>
          </c:extLst>
        </c:ser>
        <c:ser>
          <c:idx val="1"/>
          <c:order val="1"/>
          <c:tx>
            <c:strRef>
              <c:f>'[Chart in Microsoft PowerPoint]Biomass barley'!$N$7</c:f>
              <c:strCache>
                <c:ptCount val="1"/>
                <c:pt idx="0">
                  <c:v>treatment</c:v>
                </c:pt>
              </c:strCache>
            </c:strRef>
          </c:tx>
          <c:spPr>
            <a:solidFill>
              <a:srgbClr val="009999"/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[Chart in Microsoft PowerPoint]Biomass barley'!$O$9:$T$9</c:f>
                <c:numCache>
                  <c:formatCode>General</c:formatCode>
                  <c:ptCount val="6"/>
                  <c:pt idx="0">
                    <c:v>3.8850139424889281</c:v>
                  </c:pt>
                  <c:pt idx="1">
                    <c:v>11.45994332123532</c:v>
                  </c:pt>
                  <c:pt idx="2">
                    <c:v>3.3949521351559637</c:v>
                  </c:pt>
                  <c:pt idx="3">
                    <c:v>25.392104707595269</c:v>
                  </c:pt>
                  <c:pt idx="4">
                    <c:v>10.577351765464286</c:v>
                  </c:pt>
                  <c:pt idx="5">
                    <c:v>0.97805521316539601</c:v>
                  </c:pt>
                </c:numCache>
              </c:numRef>
            </c:plus>
            <c:minus>
              <c:numRef>
                <c:f>'[Chart in Microsoft PowerPoint]Biomass barley'!$O$9:$T$9</c:f>
                <c:numCache>
                  <c:formatCode>General</c:formatCode>
                  <c:ptCount val="6"/>
                  <c:pt idx="0">
                    <c:v>3.8850139424889281</c:v>
                  </c:pt>
                  <c:pt idx="1">
                    <c:v>11.45994332123532</c:v>
                  </c:pt>
                  <c:pt idx="2">
                    <c:v>3.3949521351559637</c:v>
                  </c:pt>
                  <c:pt idx="3">
                    <c:v>25.392104707595269</c:v>
                  </c:pt>
                  <c:pt idx="4">
                    <c:v>10.577351765464286</c:v>
                  </c:pt>
                  <c:pt idx="5">
                    <c:v>0.978055213165396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Biomass barley'!$O$5:$T$5</c:f>
              <c:strCache>
                <c:ptCount val="6"/>
                <c:pt idx="0">
                  <c:v>root, 1h</c:v>
                </c:pt>
                <c:pt idx="1">
                  <c:v>root, 3h</c:v>
                </c:pt>
                <c:pt idx="2">
                  <c:v>root, 6h</c:v>
                </c:pt>
                <c:pt idx="3">
                  <c:v>shoot, 1h</c:v>
                </c:pt>
                <c:pt idx="4">
                  <c:v>shoot, 3h</c:v>
                </c:pt>
                <c:pt idx="5">
                  <c:v>shoot, 6h</c:v>
                </c:pt>
              </c:strCache>
            </c:strRef>
          </c:cat>
          <c:val>
            <c:numRef>
              <c:f>'[Chart in Microsoft PowerPoint]Biomass barley'!$O$7:$T$7</c:f>
              <c:numCache>
                <c:formatCode>General</c:formatCode>
                <c:ptCount val="6"/>
                <c:pt idx="0">
                  <c:v>86.266666666666666</c:v>
                </c:pt>
                <c:pt idx="1">
                  <c:v>98.180555555555543</c:v>
                </c:pt>
                <c:pt idx="2">
                  <c:v>93.57</c:v>
                </c:pt>
                <c:pt idx="3">
                  <c:v>119.67222222222222</c:v>
                </c:pt>
                <c:pt idx="4">
                  <c:v>102.5222222222222</c:v>
                </c:pt>
                <c:pt idx="5">
                  <c:v>93.007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40A0-4423-ACD8-B9458121A1D5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338220472"/>
        <c:axId val="338221256"/>
      </c:barChart>
      <c:catAx>
        <c:axId val="3382204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38221256"/>
        <c:crosses val="autoZero"/>
        <c:auto val="1"/>
        <c:lblAlgn val="ctr"/>
        <c:lblOffset val="100"/>
        <c:noMultiLvlLbl val="0"/>
      </c:catAx>
      <c:valAx>
        <c:axId val="3382212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b="1"/>
                  <a:t>biomass weight(mg)</a:t>
                </a:r>
              </a:p>
            </c:rich>
          </c:tx>
          <c:layout>
            <c:manualLayout>
              <c:xMode val="edge"/>
              <c:yMode val="edge"/>
              <c:x val="2.5778729638637692E-2"/>
              <c:y val="0.2577066068988567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3382204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498867993703097"/>
          <c:y val="0.91034773853034279"/>
          <c:w val="0.30022616503102151"/>
          <c:h val="8.965226146965722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 sz="1000" dirty="0"/>
          </a:p>
        </c:rich>
      </c:tx>
      <c:layout>
        <c:manualLayout>
          <c:xMode val="edge"/>
          <c:yMode val="edge"/>
          <c:x val="0.13910541319808276"/>
          <c:y val="9.2592592592592587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34228227326996224"/>
          <c:y val="0.19486111111111112"/>
          <c:w val="0.63562850766410339"/>
          <c:h val="0.6597532079323418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lenght of Short exposure on ms'!$V$21</c:f>
              <c:strCache>
                <c:ptCount val="1"/>
                <c:pt idx="0">
                  <c:v>seed germination rate</c:v>
                </c:pt>
              </c:strCache>
            </c:strRef>
          </c:tx>
          <c:spPr>
            <a:solidFill>
              <a:schemeClr val="accent4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7E8-4F4A-B6CE-46F69C643374}"/>
              </c:ext>
            </c:extLst>
          </c:dPt>
          <c:dPt>
            <c:idx val="1"/>
            <c:invertIfNegative val="0"/>
            <c:bubble3D val="0"/>
            <c:spPr>
              <a:solidFill>
                <a:srgbClr val="009999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7E8-4F4A-B6CE-46F69C643374}"/>
              </c:ext>
            </c:extLst>
          </c:dPt>
          <c:dLbls>
            <c:dLbl>
              <c:idx val="0"/>
              <c:layout>
                <c:manualLayout>
                  <c:x val="0.2055555819872969"/>
                  <c:y val="0.25228499846610081"/>
                </c:manualLayout>
              </c:layout>
              <c:tx>
                <c:rich>
                  <a:bodyPr rot="-5400000" spcFirstLastPara="1" vertOverflow="ellipsis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1000" b="1" i="0" u="none" strike="noStrike" kern="1200" baseline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sz="1000" b="1"/>
                      <a:t>P</a:t>
                    </a:r>
                    <a:r>
                      <a:rPr lang="en-US" sz="1000" b="1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≤0.05</a:t>
                    </a:r>
                    <a:endParaRPr lang="en-US" sz="1000" b="1"/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-5400000" spcFirstLastPara="1" vertOverflow="ellipsis" wrap="square" lIns="38100" tIns="19050" rIns="38100" bIns="19050" anchor="ctr" anchorCtr="1">
                  <a:spAutoFit/>
                </a:bodyPr>
                <a:lstStyle/>
                <a:p>
                  <a:pPr>
                    <a:defRPr sz="1000" b="1" i="0" u="none" strike="noStrike" kern="1200" baseline="0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47E8-4F4A-B6CE-46F69C643374}"/>
                </c:ext>
              </c:extLst>
            </c:dLbl>
            <c:dLbl>
              <c:idx val="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47E8-4F4A-B6CE-46F69C64337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lenght of Short exposure on ms'!$Y$9:$Z$9</c:f>
                <c:numCache>
                  <c:formatCode>General</c:formatCode>
                  <c:ptCount val="2"/>
                  <c:pt idx="0">
                    <c:v>14.049762750072805</c:v>
                  </c:pt>
                  <c:pt idx="1">
                    <c:v>21.94073456685836</c:v>
                  </c:pt>
                </c:numCache>
              </c:numRef>
            </c:plus>
            <c:minus>
              <c:numRef>
                <c:f>'lenght of Short exposure on ms'!$Y$9:$Z$9</c:f>
                <c:numCache>
                  <c:formatCode>General</c:formatCode>
                  <c:ptCount val="2"/>
                  <c:pt idx="0">
                    <c:v>14.049762750072805</c:v>
                  </c:pt>
                  <c:pt idx="1">
                    <c:v>21.9407345668583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enght of Short exposure on ms'!$W$20:$X$20</c:f>
              <c:strCache>
                <c:ptCount val="2"/>
                <c:pt idx="0">
                  <c:v>control</c:v>
                </c:pt>
                <c:pt idx="1">
                  <c:v>treat</c:v>
                </c:pt>
              </c:strCache>
            </c:strRef>
          </c:cat>
          <c:val>
            <c:numRef>
              <c:f>'lenght of Short exposure on ms'!$W$21:$X$21</c:f>
              <c:numCache>
                <c:formatCode>General</c:formatCode>
                <c:ptCount val="2"/>
                <c:pt idx="0">
                  <c:v>78.125</c:v>
                </c:pt>
                <c:pt idx="1">
                  <c:v>40.8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A3B-C547-BE63-CC540B09C05C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409173152"/>
        <c:axId val="409169232"/>
      </c:barChart>
      <c:catAx>
        <c:axId val="4091731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09169232"/>
        <c:crosses val="autoZero"/>
        <c:auto val="1"/>
        <c:lblAlgn val="ctr"/>
        <c:lblOffset val="100"/>
        <c:noMultiLvlLbl val="0"/>
      </c:catAx>
      <c:valAx>
        <c:axId val="4091692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000" b="1"/>
                  <a:t>seed germination rate(%)</a:t>
                </a:r>
              </a:p>
            </c:rich>
          </c:tx>
          <c:layout>
            <c:manualLayout>
              <c:xMode val="edge"/>
              <c:yMode val="edge"/>
              <c:x val="7.9749031542190318E-2"/>
              <c:y val="0.154109971821706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  <a:headEnd type="none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091731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983142032619057"/>
          <c:y val="0.19826895420416854"/>
          <c:w val="0.81368433423434006"/>
          <c:h val="0.6261067796383007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biom, lenght ,barley, MS, long '!$E$12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rgbClr val="FFC000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3D7-4D36-A6D6-9DDC9F901C10}"/>
              </c:ext>
            </c:extLst>
          </c:dPt>
          <c:dLbls>
            <c:dLbl>
              <c:idx val="0"/>
              <c:layout>
                <c:manualLayout>
                  <c:x val="8.9552238805970089E-2"/>
                  <c:y val="0.2245038129430953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P≤0.01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2-93D7-4D36-A6D6-9DDC9F901C10}"/>
                </c:ext>
              </c:extLst>
            </c:dLbl>
            <c:dLbl>
              <c:idx val="1"/>
              <c:layout>
                <c:manualLayout>
                  <c:x val="6.965174129353234E-2"/>
                  <c:y val="-5.4757027547096436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P≤0.05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93D7-4D36-A6D6-9DDC9F901C10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-5400000" spcFirstLastPara="1" vertOverflow="ellipsis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biom, lenght ,barley, MS, long '!$E$16:$E$17</c:f>
                <c:numCache>
                  <c:formatCode>General</c:formatCode>
                  <c:ptCount val="2"/>
                  <c:pt idx="0">
                    <c:v>2.39</c:v>
                  </c:pt>
                  <c:pt idx="1">
                    <c:v>0.25</c:v>
                  </c:pt>
                </c:numCache>
              </c:numRef>
            </c:plus>
            <c:minus>
              <c:numRef>
                <c:f>'biom, lenght ,barley, MS, long '!$E$16:$E$17</c:f>
                <c:numCache>
                  <c:formatCode>General</c:formatCode>
                  <c:ptCount val="2"/>
                  <c:pt idx="0">
                    <c:v>2.39</c:v>
                  </c:pt>
                  <c:pt idx="1">
                    <c:v>0.2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biom, lenght ,barley, MS, long '!$D$13:$D$14</c:f>
              <c:strCache>
                <c:ptCount val="2"/>
                <c:pt idx="0">
                  <c:v>root </c:v>
                </c:pt>
                <c:pt idx="1">
                  <c:v>shoot</c:v>
                </c:pt>
              </c:strCache>
            </c:strRef>
          </c:cat>
          <c:val>
            <c:numRef>
              <c:f>'biom, lenght ,barley, MS, long '!$E$13:$E$14</c:f>
              <c:numCache>
                <c:formatCode>General</c:formatCode>
                <c:ptCount val="2"/>
                <c:pt idx="0">
                  <c:v>39.56</c:v>
                </c:pt>
                <c:pt idx="1">
                  <c:v>18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3D7-4D36-A6D6-9DDC9F901C10}"/>
            </c:ext>
          </c:extLst>
        </c:ser>
        <c:ser>
          <c:idx val="1"/>
          <c:order val="1"/>
          <c:tx>
            <c:strRef>
              <c:f>'biom, lenght ,barley, MS, long '!$F$12</c:f>
              <c:strCache>
                <c:ptCount val="1"/>
                <c:pt idx="0">
                  <c:v>treat</c:v>
                </c:pt>
              </c:strCache>
            </c:strRef>
          </c:tx>
          <c:spPr>
            <a:solidFill>
              <a:srgbClr val="4497A0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4497A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3D7-4D36-A6D6-9DDC9F901C10}"/>
              </c:ext>
            </c:extLst>
          </c:dPt>
          <c:dLbls>
            <c:delete val="1"/>
          </c:dLbls>
          <c:errBars>
            <c:errBarType val="both"/>
            <c:errValType val="cust"/>
            <c:noEndCap val="0"/>
            <c:plus>
              <c:numRef>
                <c:f>'biom, lenght ,barley, MS, long '!$F$16:$F$17</c:f>
                <c:numCache>
                  <c:formatCode>General</c:formatCode>
                  <c:ptCount val="2"/>
                  <c:pt idx="0">
                    <c:v>2.12</c:v>
                  </c:pt>
                  <c:pt idx="1">
                    <c:v>3.0139999999999998</c:v>
                  </c:pt>
                </c:numCache>
              </c:numRef>
            </c:plus>
            <c:minus>
              <c:numRef>
                <c:f>'biom, lenght ,barley, MS, long '!$F$16:$F$17</c:f>
                <c:numCache>
                  <c:formatCode>General</c:formatCode>
                  <c:ptCount val="2"/>
                  <c:pt idx="0">
                    <c:v>2.12</c:v>
                  </c:pt>
                  <c:pt idx="1">
                    <c:v>3.0139999999999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biom, lenght ,barley, MS, long '!$D$13:$D$14</c:f>
              <c:strCache>
                <c:ptCount val="2"/>
                <c:pt idx="0">
                  <c:v>root </c:v>
                </c:pt>
                <c:pt idx="1">
                  <c:v>shoot</c:v>
                </c:pt>
              </c:strCache>
            </c:strRef>
          </c:cat>
          <c:val>
            <c:numRef>
              <c:f>'biom, lenght ,barley, MS, long '!$F$13:$F$14</c:f>
              <c:numCache>
                <c:formatCode>General</c:formatCode>
                <c:ptCount val="2"/>
                <c:pt idx="0">
                  <c:v>18</c:v>
                </c:pt>
                <c:pt idx="1">
                  <c:v>12.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93D7-4D36-A6D6-9DDC9F901C10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409166880"/>
        <c:axId val="409167272"/>
      </c:barChart>
      <c:catAx>
        <c:axId val="4091668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09167272"/>
        <c:crosses val="autoZero"/>
        <c:auto val="1"/>
        <c:lblAlgn val="ctr"/>
        <c:lblOffset val="100"/>
        <c:noMultiLvlLbl val="0"/>
      </c:catAx>
      <c:valAx>
        <c:axId val="4091672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</a:rPr>
                  <a:t>lenght(m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091668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509111361079865"/>
          <c:y val="0.12842644273784826"/>
          <c:w val="0.37702734075561228"/>
          <c:h val="9.240313072227106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94340334252646"/>
          <c:y val="0.20102421992186961"/>
          <c:w val="0.81613715830249312"/>
          <c:h val="0.6123567745496563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biom, lenght ,barley, MS, long '!$E$2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rgbClr val="FFC000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FDE-4A7C-BC6B-16E644828A29}"/>
              </c:ext>
            </c:extLst>
          </c:dPt>
          <c:dLbls>
            <c:dLbl>
              <c:idx val="0"/>
              <c:layout>
                <c:manualLayout>
                  <c:x val="8.9577628653938049E-2"/>
                  <c:y val="0.2074135450339499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P≤0.001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9FDE-4A7C-BC6B-16E644828A29}"/>
                </c:ext>
              </c:extLst>
            </c:dLbl>
            <c:dLbl>
              <c:idx val="1"/>
              <c:layout>
                <c:manualLayout>
                  <c:x val="6.5727601991703549E-2"/>
                  <c:y val="4.8516121677561422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P≤0.05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2-9FDE-4A7C-BC6B-16E644828A29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-5400000" spcFirstLastPara="1" vertOverflow="ellipsis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biom, lenght ,barley, MS, long '!$E$6:$E$7</c:f>
                <c:numCache>
                  <c:formatCode>General</c:formatCode>
                  <c:ptCount val="2"/>
                  <c:pt idx="0">
                    <c:v>3.95</c:v>
                  </c:pt>
                  <c:pt idx="1">
                    <c:v>1.82</c:v>
                  </c:pt>
                </c:numCache>
              </c:numRef>
            </c:plus>
            <c:minus>
              <c:numRef>
                <c:f>'biom, lenght ,barley, MS, long '!$E$6:$E$7</c:f>
                <c:numCache>
                  <c:formatCode>General</c:formatCode>
                  <c:ptCount val="2"/>
                  <c:pt idx="0">
                    <c:v>3.95</c:v>
                  </c:pt>
                  <c:pt idx="1">
                    <c:v>1.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biom, lenght ,barley, MS, long '!$D$3:$D$4</c:f>
              <c:strCache>
                <c:ptCount val="2"/>
                <c:pt idx="0">
                  <c:v>root </c:v>
                </c:pt>
                <c:pt idx="1">
                  <c:v>shoot</c:v>
                </c:pt>
              </c:strCache>
            </c:strRef>
          </c:cat>
          <c:val>
            <c:numRef>
              <c:f>'biom, lenght ,barley, MS, long '!$E$3:$E$4</c:f>
              <c:numCache>
                <c:formatCode>General</c:formatCode>
                <c:ptCount val="2"/>
                <c:pt idx="0">
                  <c:v>51.44</c:v>
                </c:pt>
                <c:pt idx="1">
                  <c:v>27.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FDE-4A7C-BC6B-16E644828A29}"/>
            </c:ext>
          </c:extLst>
        </c:ser>
        <c:ser>
          <c:idx val="1"/>
          <c:order val="1"/>
          <c:tx>
            <c:strRef>
              <c:f>'biom, lenght ,barley, MS, long '!$F$2</c:f>
              <c:strCache>
                <c:ptCount val="1"/>
                <c:pt idx="0">
                  <c:v>treat</c:v>
                </c:pt>
              </c:strCache>
            </c:strRef>
          </c:tx>
          <c:spPr>
            <a:solidFill>
              <a:srgbClr val="4497A0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4497A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FDE-4A7C-BC6B-16E644828A29}"/>
              </c:ext>
            </c:extLst>
          </c:dPt>
          <c:dLbls>
            <c:delete val="1"/>
          </c:dLbls>
          <c:errBars>
            <c:errBarType val="both"/>
            <c:errValType val="cust"/>
            <c:noEndCap val="0"/>
            <c:plus>
              <c:numRef>
                <c:f>'biom, lenght ,barley, MS, long '!$F$6:$F$7</c:f>
                <c:numCache>
                  <c:formatCode>General</c:formatCode>
                  <c:ptCount val="2"/>
                  <c:pt idx="0">
                    <c:v>3.21</c:v>
                  </c:pt>
                  <c:pt idx="1">
                    <c:v>3.71</c:v>
                  </c:pt>
                </c:numCache>
              </c:numRef>
            </c:plus>
            <c:minus>
              <c:numRef>
                <c:f>'biom, lenght ,barley, MS, long '!$F$6:$F$7</c:f>
                <c:numCache>
                  <c:formatCode>General</c:formatCode>
                  <c:ptCount val="2"/>
                  <c:pt idx="0">
                    <c:v>3.21</c:v>
                  </c:pt>
                  <c:pt idx="1">
                    <c:v>3.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biom, lenght ,barley, MS, long '!$D$3:$D$4</c:f>
              <c:strCache>
                <c:ptCount val="2"/>
                <c:pt idx="0">
                  <c:v>root </c:v>
                </c:pt>
                <c:pt idx="1">
                  <c:v>shoot</c:v>
                </c:pt>
              </c:strCache>
            </c:strRef>
          </c:cat>
          <c:val>
            <c:numRef>
              <c:f>'biom, lenght ,barley, MS, long '!$F$3:$F$4</c:f>
              <c:numCache>
                <c:formatCode>General</c:formatCode>
                <c:ptCount val="2"/>
                <c:pt idx="0">
                  <c:v>24.84</c:v>
                </c:pt>
                <c:pt idx="1">
                  <c:v>19.35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9FDE-4A7C-BC6B-16E644828A29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409171584"/>
        <c:axId val="409168448"/>
      </c:barChart>
      <c:catAx>
        <c:axId val="4091715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09168448"/>
        <c:crosses val="autoZero"/>
        <c:auto val="1"/>
        <c:lblAlgn val="ctr"/>
        <c:lblOffset val="100"/>
        <c:noMultiLvlLbl val="0"/>
      </c:catAx>
      <c:valAx>
        <c:axId val="4091684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b="1">
                    <a:solidFill>
                      <a:sysClr val="windowText" lastClr="000000"/>
                    </a:solidFill>
                  </a:rPr>
                  <a:t>biomass</a:t>
                </a:r>
                <a:r>
                  <a:rPr lang="en-GB" b="1" baseline="0">
                    <a:solidFill>
                      <a:sysClr val="windowText" lastClr="000000"/>
                    </a:solidFill>
                  </a:rPr>
                  <a:t> weight(mg)</a:t>
                </a:r>
                <a:endParaRPr lang="en-GB" b="1">
                  <a:solidFill>
                    <a:sysClr val="windowText" lastClr="000000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091715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1772366844645736"/>
          <c:y val="8.5161803528986293E-2"/>
          <c:w val="0.27009328319448195"/>
          <c:h val="8.982104441262006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37019556450775"/>
          <c:y val="0.28107594936708863"/>
          <c:w val="0.76555740109910664"/>
          <c:h val="0.5336175620452507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barley on MS 1day'!$C$2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4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15A-495A-BB84-3948566DBC20}"/>
              </c:ext>
            </c:extLst>
          </c:dPt>
          <c:dPt>
            <c:idx val="1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515A-495A-BB84-3948566DBC20}"/>
              </c:ext>
            </c:extLst>
          </c:dPt>
          <c:dLbls>
            <c:dLbl>
              <c:idx val="0"/>
              <c:layout>
                <c:manualLayout>
                  <c:x val="7.407407407407407E-2"/>
                  <c:y val="0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P&lt;0.05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515A-495A-BB84-3948566DBC20}"/>
                </c:ext>
              </c:extLst>
            </c:dLbl>
            <c:dLbl>
              <c:idx val="1"/>
              <c:layout>
                <c:manualLayout>
                  <c:x val="7.407407407407407E-2"/>
                  <c:y val="-2.5316455696202531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P≥0.05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3-515A-495A-BB84-3948566DBC20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-5400000" spcFirstLastPara="1" vertOverflow="ellipsis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barley on MS 1day'!$C$7:$C$8</c:f>
                <c:numCache>
                  <c:formatCode>General</c:formatCode>
                  <c:ptCount val="2"/>
                  <c:pt idx="0">
                    <c:v>7.19</c:v>
                  </c:pt>
                  <c:pt idx="1">
                    <c:v>4</c:v>
                  </c:pt>
                </c:numCache>
              </c:numRef>
            </c:plus>
            <c:minus>
              <c:numRef>
                <c:f>'barley on MS 1day'!$C$7:$C$8</c:f>
                <c:numCache>
                  <c:formatCode>General</c:formatCode>
                  <c:ptCount val="2"/>
                  <c:pt idx="0">
                    <c:v>7.19</c:v>
                  </c:pt>
                  <c:pt idx="1">
                    <c:v>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barley on MS 1day'!$B$3:$B$4</c:f>
              <c:strCache>
                <c:ptCount val="2"/>
                <c:pt idx="0">
                  <c:v>Root</c:v>
                </c:pt>
                <c:pt idx="1">
                  <c:v>Shoot</c:v>
                </c:pt>
              </c:strCache>
            </c:strRef>
          </c:cat>
          <c:val>
            <c:numRef>
              <c:f>'barley on MS 1day'!$C$3:$C$4</c:f>
              <c:numCache>
                <c:formatCode>General</c:formatCode>
                <c:ptCount val="2"/>
                <c:pt idx="0">
                  <c:v>37.61</c:v>
                </c:pt>
                <c:pt idx="1">
                  <c:v>19.69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C57-DD4A-A364-E2302B93B1A5}"/>
            </c:ext>
          </c:extLst>
        </c:ser>
        <c:ser>
          <c:idx val="1"/>
          <c:order val="1"/>
          <c:tx>
            <c:strRef>
              <c:f>'barley on MS 1day'!$D$2</c:f>
              <c:strCache>
                <c:ptCount val="1"/>
                <c:pt idx="0">
                  <c:v>Treat</c:v>
                </c:pt>
              </c:strCache>
            </c:strRef>
          </c:tx>
          <c:spPr>
            <a:solidFill>
              <a:srgbClr val="4497A0"/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barley on MS 1day'!$D$7:$D$8</c:f>
                <c:numCache>
                  <c:formatCode>General</c:formatCode>
                  <c:ptCount val="2"/>
                  <c:pt idx="0">
                    <c:v>6.37</c:v>
                  </c:pt>
                  <c:pt idx="1">
                    <c:v>3.37</c:v>
                  </c:pt>
                </c:numCache>
              </c:numRef>
            </c:plus>
            <c:minus>
              <c:numRef>
                <c:f>'barley on MS 1day'!$D$7:$D$8</c:f>
                <c:numCache>
                  <c:formatCode>General</c:formatCode>
                  <c:ptCount val="2"/>
                  <c:pt idx="0">
                    <c:v>6.37</c:v>
                  </c:pt>
                  <c:pt idx="1">
                    <c:v>3.3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barley on MS 1day'!$B$3:$B$4</c:f>
              <c:strCache>
                <c:ptCount val="2"/>
                <c:pt idx="0">
                  <c:v>Root</c:v>
                </c:pt>
                <c:pt idx="1">
                  <c:v>Shoot</c:v>
                </c:pt>
              </c:strCache>
            </c:strRef>
          </c:cat>
          <c:val>
            <c:numRef>
              <c:f>'barley on MS 1day'!$D$3:$D$4</c:f>
              <c:numCache>
                <c:formatCode>General</c:formatCode>
                <c:ptCount val="2"/>
                <c:pt idx="0">
                  <c:v>29.64</c:v>
                </c:pt>
                <c:pt idx="1">
                  <c:v>16.01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C57-DD4A-A364-E2302B93B1A5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409168840"/>
        <c:axId val="409173936"/>
      </c:barChart>
      <c:catAx>
        <c:axId val="4091688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09173936"/>
        <c:crosses val="autoZero"/>
        <c:auto val="1"/>
        <c:lblAlgn val="ctr"/>
        <c:lblOffset val="100"/>
        <c:noMultiLvlLbl val="0"/>
      </c:catAx>
      <c:valAx>
        <c:axId val="4091739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b="1"/>
                  <a:t>biomass weight(mg)</a:t>
                </a:r>
              </a:p>
            </c:rich>
          </c:tx>
          <c:layout>
            <c:manualLayout>
              <c:xMode val="edge"/>
              <c:yMode val="edge"/>
              <c:x val="1.7235706696183049E-2"/>
              <c:y val="0.2557594936708860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091688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0095260985871201"/>
          <c:y val="5.1423303099770758E-2"/>
          <c:w val="0.37402976204494232"/>
          <c:h val="0.1068045450014950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603937007874016"/>
          <c:y val="0.19118178678681713"/>
          <c:w val="0.84396062992125986"/>
          <c:h val="0.649286488931793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lenght of Short exposure on ms'!$C$2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rgbClr val="FFC000"/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layout>
                <c:manualLayout>
                  <c:x val="6.9444444444444448E-2"/>
                  <c:y val="-5.5555555555555552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P≥0.05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0-846B-49BC-A34E-A97C756DD6E3}"/>
                </c:ext>
              </c:extLst>
            </c:dLbl>
            <c:dLbl>
              <c:idx val="1"/>
              <c:layout>
                <c:manualLayout>
                  <c:x val="5.5555555555555552E-2"/>
                  <c:y val="-8.3333333333333329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P≥0.05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846B-49BC-A34E-A97C756DD6E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-5400000" spcFirstLastPara="1" vertOverflow="ellipsis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lenght of Short exposure on ms'!$C$7:$C$8</c:f>
                <c:numCache>
                  <c:formatCode>General</c:formatCode>
                  <c:ptCount val="2"/>
                  <c:pt idx="0">
                    <c:v>7.69</c:v>
                  </c:pt>
                  <c:pt idx="1">
                    <c:v>3.4</c:v>
                  </c:pt>
                </c:numCache>
              </c:numRef>
            </c:plus>
            <c:minus>
              <c:numRef>
                <c:f>'lenght of Short exposure on ms'!$C$7:$C$8</c:f>
                <c:numCache>
                  <c:formatCode>General</c:formatCode>
                  <c:ptCount val="2"/>
                  <c:pt idx="0">
                    <c:v>7.69</c:v>
                  </c:pt>
                  <c:pt idx="1">
                    <c:v>3.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enght of Short exposure on ms'!$B$3:$B$4</c:f>
              <c:strCache>
                <c:ptCount val="2"/>
                <c:pt idx="0">
                  <c:v>Root</c:v>
                </c:pt>
                <c:pt idx="1">
                  <c:v>Shoot</c:v>
                </c:pt>
              </c:strCache>
            </c:strRef>
          </c:cat>
          <c:val>
            <c:numRef>
              <c:f>'lenght of Short exposure on ms'!$C$3:$C$4</c:f>
              <c:numCache>
                <c:formatCode>General</c:formatCode>
                <c:ptCount val="2"/>
                <c:pt idx="0">
                  <c:v>28.81</c:v>
                </c:pt>
                <c:pt idx="1">
                  <c:v>13.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46B-49BC-A34E-A97C756DD6E3}"/>
            </c:ext>
          </c:extLst>
        </c:ser>
        <c:ser>
          <c:idx val="1"/>
          <c:order val="1"/>
          <c:tx>
            <c:strRef>
              <c:f>'lenght of Short exposure on ms'!$D$2</c:f>
              <c:strCache>
                <c:ptCount val="1"/>
                <c:pt idx="0">
                  <c:v>Treat</c:v>
                </c:pt>
              </c:strCache>
            </c:strRef>
          </c:tx>
          <c:spPr>
            <a:solidFill>
              <a:srgbClr val="4497A0"/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'lenght of Short exposure on ms'!$D$7:$D$8</c:f>
                <c:numCache>
                  <c:formatCode>General</c:formatCode>
                  <c:ptCount val="2"/>
                  <c:pt idx="0">
                    <c:v>7.96</c:v>
                  </c:pt>
                  <c:pt idx="1">
                    <c:v>3.7</c:v>
                  </c:pt>
                </c:numCache>
              </c:numRef>
            </c:plus>
            <c:minus>
              <c:numRef>
                <c:f>'lenght of Short exposure on ms'!$D$7:$D$8</c:f>
                <c:numCache>
                  <c:formatCode>General</c:formatCode>
                  <c:ptCount val="2"/>
                  <c:pt idx="0">
                    <c:v>7.96</c:v>
                  </c:pt>
                  <c:pt idx="1">
                    <c:v>3.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lenght of Short exposure on ms'!$B$3:$B$4</c:f>
              <c:strCache>
                <c:ptCount val="2"/>
                <c:pt idx="0">
                  <c:v>Root</c:v>
                </c:pt>
                <c:pt idx="1">
                  <c:v>Shoot</c:v>
                </c:pt>
              </c:strCache>
            </c:strRef>
          </c:cat>
          <c:val>
            <c:numRef>
              <c:f>'lenght of Short exposure on ms'!$D$3:$D$4</c:f>
              <c:numCache>
                <c:formatCode>General</c:formatCode>
                <c:ptCount val="2"/>
                <c:pt idx="0">
                  <c:v>22.6</c:v>
                </c:pt>
                <c:pt idx="1">
                  <c:v>9.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46B-49BC-A34E-A97C756DD6E3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409169624"/>
        <c:axId val="409170408"/>
      </c:barChart>
      <c:catAx>
        <c:axId val="409169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09170408"/>
        <c:crosses val="autoZero"/>
        <c:auto val="1"/>
        <c:lblAlgn val="ctr"/>
        <c:lblOffset val="100"/>
        <c:noMultiLvlLbl val="0"/>
      </c:catAx>
      <c:valAx>
        <c:axId val="4091704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/>
                  <a:t>length(m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091696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4463482399849047"/>
          <c:y val="5.8980787911712844E-2"/>
          <c:w val="0.38468821803724756"/>
          <c:h val="8.181875447387260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E8496-BE01-40FB-A8ED-3EC9D4D0A6FA}" type="datetimeFigureOut">
              <a:rPr lang="de-AT" smtClean="0"/>
              <a:t>24.10.2020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19384B-B641-4D21-AB9D-ACE2599BC11F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667001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E8496-BE01-40FB-A8ED-3EC9D4D0A6FA}" type="datetimeFigureOut">
              <a:rPr lang="de-AT" smtClean="0"/>
              <a:t>24.10.2020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19384B-B641-4D21-AB9D-ACE2599BC11F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6611492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E8496-BE01-40FB-A8ED-3EC9D4D0A6FA}" type="datetimeFigureOut">
              <a:rPr lang="de-AT" smtClean="0"/>
              <a:t>24.10.2020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19384B-B641-4D21-AB9D-ACE2599BC11F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0682049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E8496-BE01-40FB-A8ED-3EC9D4D0A6FA}" type="datetimeFigureOut">
              <a:rPr lang="de-AT" smtClean="0"/>
              <a:t>24.10.2020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19384B-B641-4D21-AB9D-ACE2599BC11F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329057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E8496-BE01-40FB-A8ED-3EC9D4D0A6FA}" type="datetimeFigureOut">
              <a:rPr lang="de-AT" smtClean="0"/>
              <a:t>24.10.2020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19384B-B641-4D21-AB9D-ACE2599BC11F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9741792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E8496-BE01-40FB-A8ED-3EC9D4D0A6FA}" type="datetimeFigureOut">
              <a:rPr lang="de-AT" smtClean="0"/>
              <a:t>24.10.2020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19384B-B641-4D21-AB9D-ACE2599BC11F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721814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E8496-BE01-40FB-A8ED-3EC9D4D0A6FA}" type="datetimeFigureOut">
              <a:rPr lang="de-AT" smtClean="0"/>
              <a:t>24.10.2020</a:t>
            </a:fld>
            <a:endParaRPr lang="de-AT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19384B-B641-4D21-AB9D-ACE2599BC11F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8240936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E8496-BE01-40FB-A8ED-3EC9D4D0A6FA}" type="datetimeFigureOut">
              <a:rPr lang="de-AT" smtClean="0"/>
              <a:t>24.10.2020</a:t>
            </a:fld>
            <a:endParaRPr lang="de-AT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19384B-B641-4D21-AB9D-ACE2599BC11F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0828188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E8496-BE01-40FB-A8ED-3EC9D4D0A6FA}" type="datetimeFigureOut">
              <a:rPr lang="de-AT" smtClean="0"/>
              <a:t>24.10.2020</a:t>
            </a:fld>
            <a:endParaRPr lang="de-AT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19384B-B641-4D21-AB9D-ACE2599BC11F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0639266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E8496-BE01-40FB-A8ED-3EC9D4D0A6FA}" type="datetimeFigureOut">
              <a:rPr lang="de-AT" smtClean="0"/>
              <a:t>24.10.2020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19384B-B641-4D21-AB9D-ACE2599BC11F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8537732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EE8496-BE01-40FB-A8ED-3EC9D4D0A6FA}" type="datetimeFigureOut">
              <a:rPr lang="de-AT" smtClean="0"/>
              <a:t>24.10.2020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19384B-B641-4D21-AB9D-ACE2599BC11F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511689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EE8496-BE01-40FB-A8ED-3EC9D4D0A6FA}" type="datetimeFigureOut">
              <a:rPr lang="de-AT" smtClean="0"/>
              <a:t>24.10.2020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19384B-B641-4D21-AB9D-ACE2599BC11F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91799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.xml"/><Relationship Id="rId3" Type="http://schemas.openxmlformats.org/officeDocument/2006/relationships/image" Target="../media/image3.jpeg"/><Relationship Id="rId7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jpeg"/><Relationship Id="rId5" Type="http://schemas.openxmlformats.org/officeDocument/2006/relationships/image" Target="../media/image5.jpeg"/><Relationship Id="rId4" Type="http://schemas.openxmlformats.org/officeDocument/2006/relationships/image" Target="../media/image4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8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215295" y="2283934"/>
            <a:ext cx="630306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s</a:t>
            </a:r>
          </a:p>
        </p:txBody>
      </p:sp>
    </p:spTree>
    <p:extLst>
      <p:ext uri="{BB962C8B-B14F-4D97-AF65-F5344CB8AC3E}">
        <p14:creationId xmlns:p14="http://schemas.microsoft.com/office/powerpoint/2010/main" val="33148606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3449782" y="1343891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7" name="Rectangle 8"/>
          <p:cNvSpPr>
            <a:spLocks noChangeArrowheads="1"/>
          </p:cNvSpPr>
          <p:nvPr/>
        </p:nvSpPr>
        <p:spPr bwMode="auto">
          <a:xfrm>
            <a:off x="1589314" y="5048535"/>
            <a:ext cx="1135888" cy="12772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kumimoji="0" lang="en-US" altLang="en-US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kumimoji="0" lang="en-GB" altLang="en-US" sz="12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kumimoji="0" lang="en-US" altLang="en-US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3077029" y="1640114"/>
            <a:ext cx="6386285" cy="3222172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9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9782" y="2123354"/>
            <a:ext cx="2667000" cy="18494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TextBox 13"/>
          <p:cNvSpPr txBox="1">
            <a:spLocks noChangeArrowheads="1"/>
          </p:cNvSpPr>
          <p:nvPr/>
        </p:nvSpPr>
        <p:spPr bwMode="auto">
          <a:xfrm>
            <a:off x="7075632" y="4264891"/>
            <a:ext cx="501650" cy="301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AT" altLang="en-US" sz="14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B)</a:t>
            </a:r>
            <a:endParaRPr kumimoji="0" lang="de-AT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1" name="TextBox 15"/>
          <p:cNvSpPr txBox="1">
            <a:spLocks noChangeArrowheads="1"/>
          </p:cNvSpPr>
          <p:nvPr/>
        </p:nvSpPr>
        <p:spPr bwMode="auto">
          <a:xfrm>
            <a:off x="3449782" y="4264891"/>
            <a:ext cx="520700" cy="301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AT" altLang="en-US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</a:t>
            </a:r>
            <a:endParaRPr kumimoji="0" lang="de-AT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22" name="Picture 1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12032" y="2139229"/>
            <a:ext cx="3070225" cy="18351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530409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4"/>
          <p:cNvSpPr>
            <a:spLocks noChangeArrowheads="1"/>
          </p:cNvSpPr>
          <p:nvPr/>
        </p:nvSpPr>
        <p:spPr bwMode="auto">
          <a:xfrm>
            <a:off x="0" y="158115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3" name="Rectangle 17"/>
          <p:cNvSpPr>
            <a:spLocks noChangeArrowheads="1"/>
          </p:cNvSpPr>
          <p:nvPr/>
        </p:nvSpPr>
        <p:spPr bwMode="auto">
          <a:xfrm>
            <a:off x="0" y="158115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/>
            </a:r>
            <a:br>
              <a: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</a:br>
            <a:endParaRPr kumimoji="0" lang="en-GB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" name="Rectangle 19"/>
          <p:cNvSpPr>
            <a:spLocks noChangeArrowheads="1"/>
          </p:cNvSpPr>
          <p:nvPr/>
        </p:nvSpPr>
        <p:spPr bwMode="auto">
          <a:xfrm>
            <a:off x="666337" y="5629755"/>
            <a:ext cx="12192000" cy="9541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2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kumimoji="0" lang="en-GB" altLang="en-US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1320929" y="890687"/>
            <a:ext cx="8868029" cy="4578679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21" name="Chart 20"/>
          <p:cNvGraphicFramePr/>
          <p:nvPr>
            <p:extLst/>
          </p:nvPr>
        </p:nvGraphicFramePr>
        <p:xfrm>
          <a:off x="6667233" y="1024977"/>
          <a:ext cx="2797011" cy="16895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24" name="Picture 7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25779" y="1383373"/>
            <a:ext cx="1181476" cy="11148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8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9374" y="1383373"/>
            <a:ext cx="1198286" cy="11380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9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89779" y="1395113"/>
            <a:ext cx="1203108" cy="11262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Content Placeholder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8461" y="1395113"/>
            <a:ext cx="1187450" cy="10913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8" name="TextBox 19"/>
          <p:cNvSpPr txBox="1">
            <a:spLocks noChangeArrowheads="1"/>
          </p:cNvSpPr>
          <p:nvPr/>
        </p:nvSpPr>
        <p:spPr bwMode="auto">
          <a:xfrm>
            <a:off x="1697708" y="2576014"/>
            <a:ext cx="858202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AT" alt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(A)                       (B)                       (C)                        (D)                          </a:t>
            </a:r>
            <a:r>
              <a:rPr lang="en-GB" altLang="en-US" sz="1200" dirty="0" smtClean="0"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kumimoji="0" lang="de-AT" alt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E)</a:t>
            </a:r>
            <a:endParaRPr kumimoji="0" lang="de-AT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9" name="TextBox 20"/>
          <p:cNvSpPr txBox="1">
            <a:spLocks noChangeArrowheads="1"/>
          </p:cNvSpPr>
          <p:nvPr/>
        </p:nvSpPr>
        <p:spPr bwMode="auto">
          <a:xfrm>
            <a:off x="1826404" y="5009034"/>
            <a:ext cx="48577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AT" alt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F)</a:t>
            </a:r>
            <a:endParaRPr kumimoji="0" lang="de-AT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" name="TextBox 14"/>
          <p:cNvSpPr txBox="1">
            <a:spLocks noChangeArrowheads="1"/>
          </p:cNvSpPr>
          <p:nvPr/>
        </p:nvSpPr>
        <p:spPr bwMode="auto">
          <a:xfrm>
            <a:off x="5914730" y="5001201"/>
            <a:ext cx="55403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AT" alt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G)</a:t>
            </a:r>
            <a:endParaRPr kumimoji="0" lang="de-AT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1" name="Rectangle 13"/>
          <p:cNvSpPr>
            <a:spLocks noChangeArrowheads="1"/>
          </p:cNvSpPr>
          <p:nvPr/>
        </p:nvSpPr>
        <p:spPr bwMode="auto">
          <a:xfrm>
            <a:off x="146803" y="422484"/>
            <a:ext cx="5727523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     </a:t>
            </a:r>
            <a:r>
              <a:rPr kumimoji="0" lang="en-US" altLang="en-US" sz="2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</a:t>
            </a:r>
            <a:r>
              <a:rPr kumimoji="0" lang="en-US" altLang="en-US" sz="2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     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                                                                 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32" name="Chart 31"/>
          <p:cNvGraphicFramePr>
            <a:graphicFrameLocks/>
          </p:cNvGraphicFramePr>
          <p:nvPr>
            <p:extLst/>
          </p:nvPr>
        </p:nvGraphicFramePr>
        <p:xfrm>
          <a:off x="1623362" y="2593563"/>
          <a:ext cx="4262438" cy="250507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33" name="Chart 32"/>
          <p:cNvGraphicFramePr>
            <a:graphicFrameLocks/>
          </p:cNvGraphicFramePr>
          <p:nvPr>
            <p:extLst/>
          </p:nvPr>
        </p:nvGraphicFramePr>
        <p:xfrm>
          <a:off x="5754944" y="2813031"/>
          <a:ext cx="4233192" cy="23905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</p:spTree>
    <p:extLst>
      <p:ext uri="{BB962C8B-B14F-4D97-AF65-F5344CB8AC3E}">
        <p14:creationId xmlns:p14="http://schemas.microsoft.com/office/powerpoint/2010/main" val="31937989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7"/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0" name="Rectangle 8"/>
          <p:cNvSpPr>
            <a:spLocks noChangeArrowheads="1"/>
          </p:cNvSpPr>
          <p:nvPr/>
        </p:nvSpPr>
        <p:spPr bwMode="auto">
          <a:xfrm>
            <a:off x="0" y="16383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1" name="Rectangle 9"/>
          <p:cNvSpPr>
            <a:spLocks noChangeArrowheads="1"/>
          </p:cNvSpPr>
          <p:nvPr/>
        </p:nvSpPr>
        <p:spPr bwMode="auto">
          <a:xfrm>
            <a:off x="0" y="27813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2" name="Rectangle 11"/>
          <p:cNvSpPr>
            <a:spLocks noChangeArrowheads="1"/>
          </p:cNvSpPr>
          <p:nvPr/>
        </p:nvSpPr>
        <p:spPr bwMode="auto">
          <a:xfrm>
            <a:off x="0" y="27813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1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/>
            </a:r>
            <a:br>
              <a: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</a:br>
            <a:endParaRPr kumimoji="0" lang="en-GB" altLang="en-US" sz="12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" name="Rectangle 13"/>
          <p:cNvSpPr>
            <a:spLocks noChangeArrowheads="1"/>
          </p:cNvSpPr>
          <p:nvPr/>
        </p:nvSpPr>
        <p:spPr bwMode="auto">
          <a:xfrm>
            <a:off x="0" y="27813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4" name="Rectangle 14"/>
          <p:cNvSpPr>
            <a:spLocks noChangeArrowheads="1"/>
          </p:cNvSpPr>
          <p:nvPr/>
        </p:nvSpPr>
        <p:spPr bwMode="auto">
          <a:xfrm>
            <a:off x="632691" y="5483264"/>
            <a:ext cx="1135888" cy="8156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kumimoji="0" lang="en-GB" altLang="en-US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2280867" y="696908"/>
            <a:ext cx="6691086" cy="4470400"/>
          </a:xfrm>
          <a:prstGeom prst="rect">
            <a:avLst/>
          </a:prstGeom>
          <a:solidFill>
            <a:schemeClr val="bg1"/>
          </a:solidFill>
          <a:ln w="190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9" name="Picture 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1908" y="890496"/>
            <a:ext cx="3491202" cy="15685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20" name="Chart 19"/>
          <p:cNvGraphicFramePr/>
          <p:nvPr>
            <p:extLst/>
          </p:nvPr>
        </p:nvGraphicFramePr>
        <p:xfrm>
          <a:off x="6304251" y="713249"/>
          <a:ext cx="1975645" cy="18698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1" name="TextBox 9"/>
          <p:cNvSpPr txBox="1">
            <a:spLocks noChangeArrowheads="1"/>
          </p:cNvSpPr>
          <p:nvPr/>
        </p:nvSpPr>
        <p:spPr bwMode="auto">
          <a:xfrm>
            <a:off x="2808864" y="2483628"/>
            <a:ext cx="4913313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AT" altLang="en-US" sz="16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A)                                 (B)                                      (C)</a:t>
            </a:r>
            <a:endParaRPr kumimoji="0" lang="de-AT" altLang="en-US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2" name="TextBox 11"/>
          <p:cNvSpPr txBox="1">
            <a:spLocks noChangeArrowheads="1"/>
          </p:cNvSpPr>
          <p:nvPr/>
        </p:nvSpPr>
        <p:spPr bwMode="auto">
          <a:xfrm>
            <a:off x="2791908" y="4740024"/>
            <a:ext cx="5487988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AT" altLang="en-US" sz="1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   (D)                                                               (E)</a:t>
            </a:r>
            <a:endParaRPr kumimoji="0" lang="de-AT" altLang="en-US" sz="16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23" name="Chart 22"/>
          <p:cNvGraphicFramePr>
            <a:graphicFrameLocks/>
          </p:cNvGraphicFramePr>
          <p:nvPr>
            <p:extLst/>
          </p:nvPr>
        </p:nvGraphicFramePr>
        <p:xfrm>
          <a:off x="2597752" y="2713979"/>
          <a:ext cx="3027272" cy="22548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4" name="Chart 23"/>
          <p:cNvGraphicFramePr>
            <a:graphicFrameLocks/>
          </p:cNvGraphicFramePr>
          <p:nvPr>
            <p:extLst/>
          </p:nvPr>
        </p:nvGraphicFramePr>
        <p:xfrm>
          <a:off x="5689933" y="2801415"/>
          <a:ext cx="3181725" cy="21473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18993163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6"/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9" name="Rectangle 8"/>
          <p:cNvSpPr>
            <a:spLocks noChangeArrowheads="1"/>
          </p:cNvSpPr>
          <p:nvPr/>
        </p:nvSpPr>
        <p:spPr bwMode="auto">
          <a:xfrm>
            <a:off x="0" y="4572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0" name="Rectangle 9"/>
          <p:cNvSpPr>
            <a:spLocks noChangeArrowheads="1"/>
          </p:cNvSpPr>
          <p:nvPr/>
        </p:nvSpPr>
        <p:spPr bwMode="auto">
          <a:xfrm>
            <a:off x="0" y="192405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12" name="Rectangle 12"/>
          <p:cNvSpPr>
            <a:spLocks noChangeArrowheads="1"/>
          </p:cNvSpPr>
          <p:nvPr/>
        </p:nvSpPr>
        <p:spPr bwMode="auto">
          <a:xfrm>
            <a:off x="1187771" y="4934422"/>
            <a:ext cx="1135888" cy="12772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1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/>
            </a:r>
            <a:br>
              <a: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</a:br>
            <a:endParaRPr kumimoji="0" lang="en-GB" alt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endParaRPr kumimoji="0" lang="en-US" altLang="en-US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2949676" y="290287"/>
            <a:ext cx="5756173" cy="4748488"/>
          </a:xfrm>
          <a:prstGeom prst="rect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7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1607" y="596545"/>
            <a:ext cx="3741964" cy="17253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TextBox 8"/>
          <p:cNvSpPr txBox="1">
            <a:spLocks noChangeArrowheads="1"/>
          </p:cNvSpPr>
          <p:nvPr/>
        </p:nvSpPr>
        <p:spPr bwMode="auto">
          <a:xfrm>
            <a:off x="3132194" y="2292200"/>
            <a:ext cx="371951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AT" alt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                 (A)                                             (B)</a:t>
            </a:r>
            <a:endParaRPr kumimoji="0" lang="de-AT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" name="TextBox 10"/>
          <p:cNvSpPr txBox="1">
            <a:spLocks noChangeArrowheads="1"/>
          </p:cNvSpPr>
          <p:nvPr/>
        </p:nvSpPr>
        <p:spPr bwMode="auto">
          <a:xfrm>
            <a:off x="3334316" y="4458686"/>
            <a:ext cx="545147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AT" alt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C)                                                                 (D)</a:t>
            </a:r>
            <a:endParaRPr kumimoji="0" lang="de-AT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20" name="Chart 19">
            <a:extLst>
              <a:ext uri="{FF2B5EF4-FFF2-40B4-BE49-F238E27FC236}">
                <a16:creationId xmlns:a16="http://schemas.microsoft.com/office/drawing/2014/main" id="{B223F9CA-D3DA-0142-8519-BBC74D45FA68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5829640" y="2550797"/>
          <a:ext cx="2887436" cy="2006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1" name="Chart 20"/>
          <p:cNvGraphicFramePr>
            <a:graphicFrameLocks/>
          </p:cNvGraphicFramePr>
          <p:nvPr>
            <p:extLst/>
          </p:nvPr>
        </p:nvGraphicFramePr>
        <p:xfrm>
          <a:off x="3120968" y="2612169"/>
          <a:ext cx="2697446" cy="18819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6767722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5543" y="365125"/>
            <a:ext cx="3106057" cy="6006646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447120" y="6002439"/>
            <a:ext cx="11358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S5</a:t>
            </a:r>
            <a:endParaRPr lang="en-US" b="1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32067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9</Words>
  <Application>Microsoft Office PowerPoint</Application>
  <PresentationFormat>Breitbild</PresentationFormat>
  <Paragraphs>60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English</dc:creator>
  <cp:lastModifiedBy>English</cp:lastModifiedBy>
  <cp:revision>1</cp:revision>
  <dcterms:created xsi:type="dcterms:W3CDTF">2020-10-24T12:17:58Z</dcterms:created>
  <dcterms:modified xsi:type="dcterms:W3CDTF">2020-10-24T12:18:24Z</dcterms:modified>
</cp:coreProperties>
</file>